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73" r:id="rId3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4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01630-3734-4B97-BFDB-288B5B291284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C27C2-B793-497F-96DD-5729BB9B1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839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01630-3734-4B97-BFDB-288B5B291284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C27C2-B793-497F-96DD-5729BB9B1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348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01630-3734-4B97-BFDB-288B5B291284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C27C2-B793-497F-96DD-5729BB9B1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127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01630-3734-4B97-BFDB-288B5B291284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C27C2-B793-497F-96DD-5729BB9B1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394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01630-3734-4B97-BFDB-288B5B291284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C27C2-B793-497F-96DD-5729BB9B1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453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01630-3734-4B97-BFDB-288B5B291284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C27C2-B793-497F-96DD-5729BB9B1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6413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01630-3734-4B97-BFDB-288B5B291284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C27C2-B793-497F-96DD-5729BB9B1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649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01630-3734-4B97-BFDB-288B5B291284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C27C2-B793-497F-96DD-5729BB9B1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581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01630-3734-4B97-BFDB-288B5B291284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C27C2-B793-497F-96DD-5729BB9B1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211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01630-3734-4B97-BFDB-288B5B291284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C27C2-B793-497F-96DD-5729BB9B1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047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01630-3734-4B97-BFDB-288B5B291284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C27C2-B793-497F-96DD-5729BB9B1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210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A01630-3734-4B97-BFDB-288B5B291284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5C27C2-B793-497F-96DD-5729BB9B1D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767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465512" y="1354493"/>
          <a:ext cx="11308375" cy="383224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17780">
                  <a:extLst>
                    <a:ext uri="{9D8B030D-6E8A-4147-A177-3AD203B41FA5}">
                      <a16:colId xmlns:a16="http://schemas.microsoft.com/office/drawing/2014/main" val="1538047532"/>
                    </a:ext>
                  </a:extLst>
                </a:gridCol>
                <a:gridCol w="1595392">
                  <a:extLst>
                    <a:ext uri="{9D8B030D-6E8A-4147-A177-3AD203B41FA5}">
                      <a16:colId xmlns:a16="http://schemas.microsoft.com/office/drawing/2014/main" val="1551411641"/>
                    </a:ext>
                  </a:extLst>
                </a:gridCol>
                <a:gridCol w="1263018">
                  <a:extLst>
                    <a:ext uri="{9D8B030D-6E8A-4147-A177-3AD203B41FA5}">
                      <a16:colId xmlns:a16="http://schemas.microsoft.com/office/drawing/2014/main" val="3271814396"/>
                    </a:ext>
                  </a:extLst>
                </a:gridCol>
                <a:gridCol w="1628630">
                  <a:extLst>
                    <a:ext uri="{9D8B030D-6E8A-4147-A177-3AD203B41FA5}">
                      <a16:colId xmlns:a16="http://schemas.microsoft.com/office/drawing/2014/main" val="2199892980"/>
                    </a:ext>
                  </a:extLst>
                </a:gridCol>
                <a:gridCol w="2251829">
                  <a:extLst>
                    <a:ext uri="{9D8B030D-6E8A-4147-A177-3AD203B41FA5}">
                      <a16:colId xmlns:a16="http://schemas.microsoft.com/office/drawing/2014/main" val="91198352"/>
                    </a:ext>
                  </a:extLst>
                </a:gridCol>
                <a:gridCol w="3351726">
                  <a:extLst>
                    <a:ext uri="{9D8B030D-6E8A-4147-A177-3AD203B41FA5}">
                      <a16:colId xmlns:a16="http://schemas.microsoft.com/office/drawing/2014/main" val="3518388469"/>
                    </a:ext>
                  </a:extLst>
                </a:gridCol>
              </a:tblGrid>
              <a:tr h="637089">
                <a:tc>
                  <a:txBody>
                    <a:bodyPr/>
                    <a:lstStyle/>
                    <a:p>
                      <a:pPr algn="ctr"/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Age (year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Se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Ethnic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Anatomical Si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Initial Clinical Impression/</a:t>
                      </a:r>
                    </a:p>
                    <a:p>
                      <a:pPr algn="ctr"/>
                      <a:r>
                        <a:rPr lang="en-US" sz="1800" dirty="0"/>
                        <a:t>Diagnosi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07838885"/>
                  </a:ext>
                </a:extLst>
              </a:tr>
              <a:tr h="656529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1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/>
                        <a:t>Female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/>
                        <a:t>Caucasian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Lower lip, right sid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Mucocele, calcified minor salivary gland, sialadeniti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56427627"/>
                  </a:ext>
                </a:extLst>
              </a:tr>
              <a:tr h="459043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2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/>
                        <a:t>Female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/>
                        <a:t>Caucasian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Lower lip, right sid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Mucocele, traumatic fibrom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75708256"/>
                  </a:ext>
                </a:extLst>
              </a:tr>
              <a:tr h="345826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3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/>
                        <a:t>Male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/>
                        <a:t>Caucasian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Lower lip, left sid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Mucocel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68950307"/>
                  </a:ext>
                </a:extLst>
              </a:tr>
              <a:tr h="345826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4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/>
                        <a:t>Male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/>
                        <a:t>African-American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Lower lip, left sid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Mucocel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78535971"/>
                  </a:ext>
                </a:extLst>
              </a:tr>
              <a:tr h="345826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5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/>
                        <a:t>Male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/>
                        <a:t>African-American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Lower lip, midline are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Mucocel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8242394"/>
                  </a:ext>
                </a:extLst>
              </a:tr>
              <a:tr h="345826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6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/>
                        <a:t>Female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/>
                        <a:t>Caucasian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Lower lip, right sid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Mucocel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5507013"/>
                  </a:ext>
                </a:extLst>
              </a:tr>
              <a:tr h="613557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7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/>
                        <a:t>Male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/>
                        <a:t>Caucasian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Lower lip, right sid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Mucocel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22893516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36203" y="507076"/>
            <a:ext cx="867479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 smtClean="0">
                <a:solidFill>
                  <a:srgbClr val="0070C0"/>
                </a:solidFill>
              </a:rPr>
              <a:t>Table 1A. Demographic Information of </a:t>
            </a:r>
            <a:r>
              <a:rPr lang="en-US" sz="2800" b="1" dirty="0">
                <a:solidFill>
                  <a:srgbClr val="0070C0"/>
                </a:solidFill>
              </a:rPr>
              <a:t>Control </a:t>
            </a:r>
            <a:r>
              <a:rPr lang="en-US" sz="2800" b="1" dirty="0" smtClean="0">
                <a:solidFill>
                  <a:srgbClr val="0070C0"/>
                </a:solidFill>
              </a:rPr>
              <a:t>Subjects</a:t>
            </a:r>
            <a:endParaRPr lang="en-US" sz="2800" b="1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660176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05516" y="174567"/>
            <a:ext cx="84243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0070C0"/>
                </a:solidFill>
              </a:rPr>
              <a:t>Table 1B. Demographic Information of </a:t>
            </a:r>
            <a:r>
              <a:rPr lang="en-US" b="1" dirty="0">
                <a:solidFill>
                  <a:srgbClr val="0070C0"/>
                </a:solidFill>
              </a:rPr>
              <a:t>Experimental  </a:t>
            </a:r>
            <a:r>
              <a:rPr lang="en-US" b="1" dirty="0" smtClean="0">
                <a:solidFill>
                  <a:srgbClr val="0070C0"/>
                </a:solidFill>
              </a:rPr>
              <a:t>Subjects</a:t>
            </a:r>
            <a:endParaRPr lang="en-US" b="1" dirty="0">
              <a:solidFill>
                <a:srgbClr val="0070C0"/>
              </a:solidFill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6549173"/>
              </p:ext>
            </p:extLst>
          </p:nvPr>
        </p:nvGraphicFramePr>
        <p:xfrm>
          <a:off x="721894" y="864523"/>
          <a:ext cx="10565478" cy="545640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37834">
                  <a:extLst>
                    <a:ext uri="{9D8B030D-6E8A-4147-A177-3AD203B41FA5}">
                      <a16:colId xmlns:a16="http://schemas.microsoft.com/office/drawing/2014/main" val="1538047532"/>
                    </a:ext>
                  </a:extLst>
                </a:gridCol>
                <a:gridCol w="1151963">
                  <a:extLst>
                    <a:ext uri="{9D8B030D-6E8A-4147-A177-3AD203B41FA5}">
                      <a16:colId xmlns:a16="http://schemas.microsoft.com/office/drawing/2014/main" val="1551411641"/>
                    </a:ext>
                  </a:extLst>
                </a:gridCol>
                <a:gridCol w="941748">
                  <a:extLst>
                    <a:ext uri="{9D8B030D-6E8A-4147-A177-3AD203B41FA5}">
                      <a16:colId xmlns:a16="http://schemas.microsoft.com/office/drawing/2014/main" val="3271814396"/>
                    </a:ext>
                  </a:extLst>
                </a:gridCol>
                <a:gridCol w="1304806">
                  <a:extLst>
                    <a:ext uri="{9D8B030D-6E8A-4147-A177-3AD203B41FA5}">
                      <a16:colId xmlns:a16="http://schemas.microsoft.com/office/drawing/2014/main" val="2199892980"/>
                    </a:ext>
                  </a:extLst>
                </a:gridCol>
                <a:gridCol w="2007365">
                  <a:extLst>
                    <a:ext uri="{9D8B030D-6E8A-4147-A177-3AD203B41FA5}">
                      <a16:colId xmlns:a16="http://schemas.microsoft.com/office/drawing/2014/main" val="91198352"/>
                    </a:ext>
                  </a:extLst>
                </a:gridCol>
                <a:gridCol w="3721762">
                  <a:extLst>
                    <a:ext uri="{9D8B030D-6E8A-4147-A177-3AD203B41FA5}">
                      <a16:colId xmlns:a16="http://schemas.microsoft.com/office/drawing/2014/main" val="3518388469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Age (year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Se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Ethnic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Anatomical Si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Initial Clinical Impression/ </a:t>
                      </a:r>
                      <a:endParaRPr lang="en-US" sz="1800" dirty="0" smtClean="0"/>
                    </a:p>
                    <a:p>
                      <a:pPr algn="ctr"/>
                      <a:r>
                        <a:rPr lang="en-US" sz="1800" dirty="0" smtClean="0"/>
                        <a:t>Diagnosis</a:t>
                      </a:r>
                      <a:endParaRPr lang="en-US" sz="1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07838885"/>
                  </a:ext>
                </a:extLst>
              </a:tr>
              <a:tr h="349135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1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4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Femal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Hispanic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ower Li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Suspected </a:t>
                      </a:r>
                      <a:r>
                        <a:rPr lang="en-US" sz="1200" dirty="0" err="1" smtClean="0"/>
                        <a:t>Sjogren</a:t>
                      </a:r>
                      <a:r>
                        <a:rPr lang="en-US" sz="1200" dirty="0" smtClean="0"/>
                        <a:t> </a:t>
                      </a:r>
                      <a:r>
                        <a:rPr lang="en-US" sz="1200" dirty="0"/>
                        <a:t>s</a:t>
                      </a:r>
                      <a:r>
                        <a:rPr lang="en-US" sz="1200" dirty="0" smtClean="0"/>
                        <a:t>yndrome 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56427627"/>
                  </a:ext>
                </a:extLst>
              </a:tr>
              <a:tr h="382386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2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6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Femal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Caucasia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ower li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Suspected </a:t>
                      </a:r>
                      <a:r>
                        <a:rPr lang="en-US" sz="1200" dirty="0" err="1" smtClean="0"/>
                        <a:t>Sjogren</a:t>
                      </a:r>
                      <a:r>
                        <a:rPr lang="en-US" sz="1200" dirty="0" smtClean="0"/>
                        <a:t> </a:t>
                      </a:r>
                      <a:r>
                        <a:rPr lang="en-US" sz="1200" dirty="0"/>
                        <a:t>syndrom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75708256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3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Femal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Caucasia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ower li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Recurrent aphthous ulcer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68950307"/>
                  </a:ext>
                </a:extLst>
              </a:tr>
              <a:tr h="332509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4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Femal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Caucasia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ower lip, right sid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Suspected Sjogren's syndrom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78535971"/>
                  </a:ext>
                </a:extLst>
              </a:tr>
              <a:tr h="340822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5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Femal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Caucasia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ower lip, right side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Suspected</a:t>
                      </a:r>
                      <a:r>
                        <a:rPr lang="en-US" sz="1200" baseline="0" dirty="0" smtClean="0"/>
                        <a:t> </a:t>
                      </a:r>
                      <a:r>
                        <a:rPr lang="en-US" sz="1200" dirty="0" err="1" smtClean="0"/>
                        <a:t>Sjogren's</a:t>
                      </a:r>
                      <a:r>
                        <a:rPr lang="en-US" sz="1200" dirty="0" smtClean="0"/>
                        <a:t> </a:t>
                      </a:r>
                      <a:r>
                        <a:rPr lang="en-US" sz="1200" dirty="0"/>
                        <a:t>syndrom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8242394"/>
                  </a:ext>
                </a:extLst>
              </a:tr>
              <a:tr h="374073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6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Femal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Caucasia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ower li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Rule </a:t>
                      </a:r>
                      <a:r>
                        <a:rPr lang="en-US" sz="1200" dirty="0"/>
                        <a:t>out </a:t>
                      </a:r>
                      <a:r>
                        <a:rPr lang="en-US" sz="1200" dirty="0" err="1"/>
                        <a:t>Sjogren</a:t>
                      </a:r>
                      <a:r>
                        <a:rPr lang="en-US" sz="1200" dirty="0"/>
                        <a:t> </a:t>
                      </a:r>
                      <a:r>
                        <a:rPr lang="en-US" sz="1200" dirty="0" smtClean="0"/>
                        <a:t>syndrome; Granuloma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5507013"/>
                  </a:ext>
                </a:extLst>
              </a:tr>
              <a:tr h="440574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7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6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Mal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Caucasia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ower Li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pt-BR" sz="1200" dirty="0" smtClean="0"/>
                        <a:t>Rule out Sjogren's </a:t>
                      </a:r>
                      <a:r>
                        <a:rPr lang="pt-BR" sz="1200" dirty="0"/>
                        <a:t>syndrome, Traumatic</a:t>
                      </a:r>
                      <a:r>
                        <a:rPr lang="pt-BR" sz="1200" dirty="0" smtClean="0"/>
                        <a:t>, </a:t>
                      </a:r>
                      <a:r>
                        <a:rPr lang="pt-BR" sz="1200" dirty="0"/>
                        <a:t>Candidal Ulceration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22893516"/>
                  </a:ext>
                </a:extLst>
              </a:tr>
              <a:tr h="382385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8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Femal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Caucasia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ower Li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pt-BR" sz="1200" dirty="0" smtClean="0"/>
                        <a:t>Suspected Sjogren's </a:t>
                      </a:r>
                      <a:r>
                        <a:rPr lang="pt-BR" sz="1200" dirty="0"/>
                        <a:t>syndrome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21034567"/>
                  </a:ext>
                </a:extLst>
              </a:tr>
              <a:tr h="349135">
                <a:tc>
                  <a:txBody>
                    <a:bodyPr/>
                    <a:lstStyle/>
                    <a:p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9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4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Femal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Hispanic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eft Paroti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1200" dirty="0" smtClean="0"/>
                        <a:t>Suspected Sjogren's </a:t>
                      </a:r>
                      <a:r>
                        <a:rPr lang="pt-BR" sz="1200" dirty="0"/>
                        <a:t>syndrome</a:t>
                      </a:r>
                      <a:endParaRPr lang="en-US" sz="1200" dirty="0"/>
                    </a:p>
                    <a:p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3693827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10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6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Femal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Caucasia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ower Lip, Left Sid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Probable Mucocele  (Evaluate for Sjogren Syndrome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74233724"/>
                  </a:ext>
                </a:extLst>
              </a:tr>
              <a:tr h="46551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11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Femal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African-America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ower Li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1200" dirty="0" smtClean="0"/>
                        <a:t>Suspected Sjogren's </a:t>
                      </a:r>
                      <a:r>
                        <a:rPr lang="pt-BR" sz="1200" dirty="0"/>
                        <a:t>syndrome</a:t>
                      </a:r>
                      <a:endParaRPr lang="en-US" sz="1200" dirty="0"/>
                    </a:p>
                    <a:p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91111124"/>
                  </a:ext>
                </a:extLst>
              </a:tr>
              <a:tr h="46877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/>
                        <a:t>Subject </a:t>
                      </a:r>
                      <a:r>
                        <a:rPr lang="en-US" sz="1800" b="1" dirty="0" smtClean="0"/>
                        <a:t>12</a:t>
                      </a:r>
                      <a:endParaRPr lang="en-US" sz="18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Femal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Caucasia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Lower Lip, Right Sid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Xerostomia, </a:t>
                      </a:r>
                      <a:r>
                        <a:rPr lang="en-US" sz="1200" dirty="0" smtClean="0"/>
                        <a:t>Rule out </a:t>
                      </a:r>
                      <a:r>
                        <a:rPr lang="pt-BR" sz="1200" dirty="0" smtClean="0"/>
                        <a:t>Sjogren's </a:t>
                      </a:r>
                      <a:r>
                        <a:rPr lang="pt-BR" sz="1200" dirty="0"/>
                        <a:t>syndrome</a:t>
                      </a:r>
                      <a:endParaRPr lang="en-US" sz="1200" dirty="0"/>
                    </a:p>
                    <a:p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806535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015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1</TotalTime>
  <Words>278</Words>
  <Application>Microsoft Office PowerPoint</Application>
  <PresentationFormat>Widescreen</PresentationFormat>
  <Paragraphs>12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Augusta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zaffari, Mahmood S.</dc:creator>
  <cp:lastModifiedBy>Mozaffari, Mahmood S.</cp:lastModifiedBy>
  <cp:revision>22</cp:revision>
  <cp:lastPrinted>2025-02-27T18:48:57Z</cp:lastPrinted>
  <dcterms:created xsi:type="dcterms:W3CDTF">2024-07-23T19:29:31Z</dcterms:created>
  <dcterms:modified xsi:type="dcterms:W3CDTF">2025-02-27T19:20:29Z</dcterms:modified>
</cp:coreProperties>
</file>